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D56B77-1948-2E3E-9E76-2267D9FD7C4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7E29301-CC8C-A53C-89DF-9A6CD84E24B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7224BE-77E1-EE15-4C80-F9180B5B2D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F4274-BF0B-47E2-A212-E7323861D52D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2D899A-58CD-DD9F-21BC-7A9D7952A8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4C68EE-F920-894F-59C2-4132792648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020B87-A78A-41E1-8930-C6632C52AB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82712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03C2B6-8CB2-869E-5A02-D207510874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9A5BB4D-83AF-41E2-46FE-7FBA2BCB21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9E1764-BB96-564C-AF5F-FBFBD66368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F4274-BF0B-47E2-A212-E7323861D52D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58B851-F753-AC5C-0AF9-EE00E7D2DE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4DA7A2-1244-B31A-2EBD-4AEBBDB024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020B87-A78A-41E1-8930-C6632C52AB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3494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20DB868-730B-066C-8E16-0AE964E2D7A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2DADA96-F682-19BA-1291-67852DAABE5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155C70-43FA-77B8-2CF0-C8D7BB0F74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F4274-BF0B-47E2-A212-E7323861D52D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970BA4-BC91-C84A-9F3D-A7F6BC322B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207D0A-9CC5-F4A0-73C6-426501262B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020B87-A78A-41E1-8930-C6632C52AB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3227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6B40AB-45B8-CBBF-1241-8FD2E58C88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182E24F-363C-4D89-50AA-5A317570399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722742-B98A-8D2F-05C0-A00E7537B5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F4274-BF0B-47E2-A212-E7323861D52D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748679-F2B4-FEF4-65FB-299E8B3D8A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D74831-F583-4487-E132-90D4C72D8A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020B87-A78A-41E1-8930-C6632C52AB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48117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6BAEAB-CCD8-E499-8492-6FB2958959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55535B5-A340-98BD-C918-ABDD995C08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2F35B2-5EC2-50C5-C777-5FE5E873EE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F4274-BF0B-47E2-A212-E7323861D52D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212F4D-F93D-0FCB-E050-BB2C881FEC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F9220B-8AD8-B613-A69A-C8A9A84309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020B87-A78A-41E1-8930-C6632C52AB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74869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AF4C52-8E31-7558-09FB-1ED57B3616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EE9609-2788-DAED-2312-1FC4439D064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EF0FD77-B42F-6D65-1AB9-8EE9E4EEAC3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22B3C3-9C55-2186-96C0-016F7BD65C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F4274-BF0B-47E2-A212-E7323861D52D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9BAEA6B-4DE4-F43B-C3BB-8424917959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C4B25E-96E0-F79A-E297-CE77D24A6A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020B87-A78A-41E1-8930-C6632C52AB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81936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2FE1AD-4B9B-C54F-DB02-0672BA2FC6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397D96-7049-CB19-6532-9C380A69BC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68E6571-D8ED-9C97-39BA-B6CF6979D0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876D8BD-3307-A22D-C22D-C0E9DB59939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3EE6839-727D-1CD4-A14F-88CB076771B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163BDBF-2612-695F-4E4C-515C5A12D8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F4274-BF0B-47E2-A212-E7323861D52D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4D59D2A-3586-4618-2C05-4AF0712D32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F1E9D2C-DC4A-4E63-95DA-8E898F6EE9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020B87-A78A-41E1-8930-C6632C52AB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5775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1C2F72-8479-3DB0-E250-A4AEC396DF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AF45A1A-4744-A948-CED2-2BBE9BAA1E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F4274-BF0B-47E2-A212-E7323861D52D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98170DA-3355-FD89-60E1-FF310D19BF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E65804C-4BA1-9B04-FFF0-1AEDCF2A00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020B87-A78A-41E1-8930-C6632C52AB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61258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91C4703-E7A9-013A-64F0-25D9CE69E7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F4274-BF0B-47E2-A212-E7323861D52D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2A4B7E1-1BE9-47A0-0A14-D80742600B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BCEFFB9-56D6-3200-8498-3A934D6F0C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020B87-A78A-41E1-8930-C6632C52AB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64416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6E6B47-1BCA-547D-047D-FF72AA97E7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7B9425-7DCC-F90A-3D4E-C1ABAE3DE5C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FD4896B-57A4-F803-9493-4836B9545A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8DF2DD-413F-89FE-AD59-B7B4D6DB1B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F4274-BF0B-47E2-A212-E7323861D52D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DDD4D2-9CC7-26F4-12CD-23A4018B4A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FD90CF-86FE-D31E-32E2-EA1D8DFC16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020B87-A78A-41E1-8930-C6632C52AB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7216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CDB855-D560-E7BF-B251-9042E7B11F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C78B063-E56F-F4AC-0F53-7E51C753FF7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A263568-7A33-064E-4DDE-5B3CBEC267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5C28CA-6997-0E0D-5D42-E8C5000CD3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F4274-BF0B-47E2-A212-E7323861D52D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4F11A1-7080-509F-F4C1-8726EE62E3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7DE69CF-664D-2A88-56AB-4B90CE59CC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020B87-A78A-41E1-8930-C6632C52AB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85408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69A0FA1-FA88-79F9-6823-F842D6BC44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194C83-375E-7555-E93F-E52B17DB28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B6548F-1FDF-8D4D-2DA6-52D108B5C26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EF4274-BF0B-47E2-A212-E7323861D52D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9E7882-5C12-22D9-01E4-153E256D393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05720A-FF8B-CC36-D47B-BA788EAAA17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020B87-A78A-41E1-8930-C6632C52AB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03021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8.e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5" Type="http://schemas.openxmlformats.org/officeDocument/2006/relationships/image" Target="../media/image2.emf"/><Relationship Id="rId15" Type="http://schemas.openxmlformats.org/officeDocument/2006/relationships/image" Target="../media/image7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Relationship Id="rId14" Type="http://schemas.openxmlformats.org/officeDocument/2006/relationships/oleObject" Target="../embeddings/oleObject7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>
            <a:extLst>
              <a:ext uri="{FF2B5EF4-FFF2-40B4-BE49-F238E27FC236}">
                <a16:creationId xmlns:a16="http://schemas.microsoft.com/office/drawing/2014/main" id="{7B31BD8E-6537-69E2-95A3-64133AA2EA6A}"/>
              </a:ext>
            </a:extLst>
          </p:cNvPr>
          <p:cNvGrpSpPr/>
          <p:nvPr/>
        </p:nvGrpSpPr>
        <p:grpSpPr>
          <a:xfrm>
            <a:off x="222676" y="1211047"/>
            <a:ext cx="2741613" cy="1922462"/>
            <a:chOff x="1107711" y="1506104"/>
            <a:chExt cx="2741613" cy="1922462"/>
          </a:xfrm>
        </p:grpSpPr>
        <p:graphicFrame>
          <p:nvGraphicFramePr>
            <p:cNvPr id="6" name="Object 5">
              <a:extLst>
                <a:ext uri="{FF2B5EF4-FFF2-40B4-BE49-F238E27FC236}">
                  <a16:creationId xmlns:a16="http://schemas.microsoft.com/office/drawing/2014/main" id="{5AAF3BE2-8501-7CA9-41D6-5EBC23EC2FCE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1107711" y="1506104"/>
            <a:ext cx="2741613" cy="19224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" imgW="3848050" imgH="2700075" progId="Prism9.Document">
                    <p:embed/>
                  </p:oleObj>
                </mc:Choice>
                <mc:Fallback>
                  <p:oleObj name="Prism 9" r:id="rId2" imgW="3848050" imgH="2700075" progId="Prism9.Document">
                    <p:embed/>
                    <p:pic>
                      <p:nvPicPr>
                        <p:cNvPr id="6" name="Object 5">
                          <a:extLst>
                            <a:ext uri="{FF2B5EF4-FFF2-40B4-BE49-F238E27FC236}">
                              <a16:creationId xmlns:a16="http://schemas.microsoft.com/office/drawing/2014/main" id="{5AAF3BE2-8501-7CA9-41D6-5EBC23EC2FC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1107711" y="1506104"/>
                          <a:ext cx="2741613" cy="192246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0" name="Text Box 2">
              <a:extLst>
                <a:ext uri="{FF2B5EF4-FFF2-40B4-BE49-F238E27FC236}">
                  <a16:creationId xmlns:a16="http://schemas.microsoft.com/office/drawing/2014/main" id="{70438D0B-ED4D-D9D1-E90A-C74D0EC2E6A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066143" y="2209530"/>
              <a:ext cx="678340" cy="2018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700" b="1" i="1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p</a:t>
              </a:r>
              <a:r>
                <a:rPr lang="en-US" sz="700" b="1" i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= 0.31</a:t>
              </a:r>
              <a:endParaRPr lang="en-US" sz="1100" b="1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D2CBD864-EEF1-0C68-74B8-5FC16B1FA468}"/>
              </a:ext>
            </a:extLst>
          </p:cNvPr>
          <p:cNvGrpSpPr/>
          <p:nvPr/>
        </p:nvGrpSpPr>
        <p:grpSpPr>
          <a:xfrm>
            <a:off x="3139792" y="1211047"/>
            <a:ext cx="2743200" cy="1954212"/>
            <a:chOff x="4724400" y="1481138"/>
            <a:chExt cx="2743200" cy="1954212"/>
          </a:xfrm>
        </p:grpSpPr>
        <p:graphicFrame>
          <p:nvGraphicFramePr>
            <p:cNvPr id="25" name="Object 24">
              <a:extLst>
                <a:ext uri="{FF2B5EF4-FFF2-40B4-BE49-F238E27FC236}">
                  <a16:creationId xmlns:a16="http://schemas.microsoft.com/office/drawing/2014/main" id="{EF2BB11B-3B16-A924-57A5-FC2C527BC3BA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724400" y="1481138"/>
            <a:ext cx="2743200" cy="19542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4" imgW="3852732" imgH="2744374" progId="Prism9.Document">
                    <p:embed/>
                  </p:oleObj>
                </mc:Choice>
                <mc:Fallback>
                  <p:oleObj name="Prism 9" r:id="rId4" imgW="3852732" imgH="2744374" progId="Prism9.Document">
                    <p:embed/>
                    <p:pic>
                      <p:nvPicPr>
                        <p:cNvPr id="25" name="Object 24">
                          <a:extLst>
                            <a:ext uri="{FF2B5EF4-FFF2-40B4-BE49-F238E27FC236}">
                              <a16:creationId xmlns:a16="http://schemas.microsoft.com/office/drawing/2014/main" id="{EF2BB11B-3B16-A924-57A5-FC2C527BC3B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4724400" y="1481138"/>
                          <a:ext cx="2743200" cy="19542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2" name="Text Box 2">
              <a:extLst>
                <a:ext uri="{FF2B5EF4-FFF2-40B4-BE49-F238E27FC236}">
                  <a16:creationId xmlns:a16="http://schemas.microsoft.com/office/drawing/2014/main" id="{551EEFEB-4183-616C-45C8-FEA1B6CB65C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540911" y="2236481"/>
              <a:ext cx="678340" cy="2018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700" b="1" i="1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p</a:t>
              </a:r>
              <a:r>
                <a:rPr lang="en-US" sz="700" b="1" i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= </a:t>
              </a:r>
              <a:r>
                <a:rPr lang="en-US" sz="700" b="1" i="1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0.91</a:t>
              </a:r>
              <a:endParaRPr lang="en-US" sz="1100" b="1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F5188E71-8386-98F4-61A4-E6090DEEAE8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853113" y="1187450"/>
          <a:ext cx="3044825" cy="1962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4194141" imgH="2700075" progId="Prism9.Document">
                  <p:embed/>
                </p:oleObj>
              </mc:Choice>
              <mc:Fallback>
                <p:oleObj name="Prism 9" r:id="rId6" imgW="4194141" imgH="2700075" progId="Prism9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F5188E71-8386-98F4-61A4-E6090DEEAE8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853113" y="1187450"/>
                        <a:ext cx="3044825" cy="1962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4C710A01-B5FA-2DB9-1C7D-41DB1DEFF79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930298" y="1160621"/>
          <a:ext cx="2798762" cy="1993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3852732" imgH="2744374" progId="Prism9.Document">
                  <p:embed/>
                </p:oleObj>
              </mc:Choice>
              <mc:Fallback>
                <p:oleObj name="Prism 9" r:id="rId8" imgW="3852732" imgH="2744374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4C710A01-B5FA-2DB9-1C7D-41DB1DEFF79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8930298" y="1160621"/>
                        <a:ext cx="2798762" cy="1993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7CAC8881-3C77-CF78-3D66-4EC124BA689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33363" y="3895725"/>
          <a:ext cx="2795587" cy="1962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3848050" imgH="2700075" progId="Prism9.Document">
                  <p:embed/>
                </p:oleObj>
              </mc:Choice>
              <mc:Fallback>
                <p:oleObj name="Prism 9" r:id="rId10" imgW="3848050" imgH="2700075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7CAC8881-3C77-CF78-3D66-4EC124BA689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33363" y="3895725"/>
                        <a:ext cx="2795587" cy="1962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AB6DD702-3DD8-0D56-316E-BDED233CE5E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149600" y="3765550"/>
          <a:ext cx="2811463" cy="2003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3852732" imgH="2744374" progId="Prism9.Document">
                  <p:embed/>
                </p:oleObj>
              </mc:Choice>
              <mc:Fallback>
                <p:oleObj name="Prism 9" r:id="rId12" imgW="3852732" imgH="2744374" progId="Prism9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AB6DD702-3DD8-0D56-316E-BDED233CE5E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149600" y="3765550"/>
                        <a:ext cx="2811463" cy="2003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8" name="Group 7">
            <a:extLst>
              <a:ext uri="{FF2B5EF4-FFF2-40B4-BE49-F238E27FC236}">
                <a16:creationId xmlns:a16="http://schemas.microsoft.com/office/drawing/2014/main" id="{870E1152-A3ED-E6A9-0135-A52DCF3505F8}"/>
              </a:ext>
            </a:extLst>
          </p:cNvPr>
          <p:cNvGrpSpPr/>
          <p:nvPr/>
        </p:nvGrpSpPr>
        <p:grpSpPr>
          <a:xfrm>
            <a:off x="8891588" y="3733800"/>
            <a:ext cx="2800350" cy="2000250"/>
            <a:chOff x="5273204" y="1450499"/>
            <a:chExt cx="2800350" cy="2000250"/>
          </a:xfrm>
        </p:grpSpPr>
        <p:graphicFrame>
          <p:nvGraphicFramePr>
            <p:cNvPr id="9" name="Object 8">
              <a:extLst>
                <a:ext uri="{FF2B5EF4-FFF2-40B4-BE49-F238E27FC236}">
                  <a16:creationId xmlns:a16="http://schemas.microsoft.com/office/drawing/2014/main" id="{EBDC3BE9-891E-AF63-ABBE-E176E4E01D97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5273204" y="1450499"/>
            <a:ext cx="2800350" cy="20002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4" imgW="3843368" imgH="2744374" progId="Prism9.Document">
                    <p:embed/>
                  </p:oleObj>
                </mc:Choice>
                <mc:Fallback>
                  <p:oleObj name="Prism 9" r:id="rId14" imgW="3843368" imgH="2744374" progId="Prism9.Document">
                    <p:embed/>
                    <p:pic>
                      <p:nvPicPr>
                        <p:cNvPr id="9" name="Object 8">
                          <a:extLst>
                            <a:ext uri="{FF2B5EF4-FFF2-40B4-BE49-F238E27FC236}">
                              <a16:creationId xmlns:a16="http://schemas.microsoft.com/office/drawing/2014/main" id="{EBDC3BE9-891E-AF63-ABBE-E176E4E01D9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5273204" y="1450499"/>
                          <a:ext cx="2800350" cy="20002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2" name="Text Box 2">
              <a:extLst>
                <a:ext uri="{FF2B5EF4-FFF2-40B4-BE49-F238E27FC236}">
                  <a16:creationId xmlns:a16="http://schemas.microsoft.com/office/drawing/2014/main" id="{60776F3C-25D3-1CAE-DAC5-988182BEE52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055642" y="2568317"/>
              <a:ext cx="678340" cy="2018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700" b="1" i="1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p</a:t>
              </a:r>
              <a:r>
                <a:rPr lang="en-US" sz="700" b="1" i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= &lt;</a:t>
              </a:r>
              <a:r>
                <a:rPr lang="en-US" sz="700" b="1" i="1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0.0001</a:t>
              </a:r>
              <a:endParaRPr lang="en-US" sz="1100" b="1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653CBC60-A8F4-39DD-E557-47B63B356150}"/>
              </a:ext>
            </a:extLst>
          </p:cNvPr>
          <p:cNvGrpSpPr/>
          <p:nvPr/>
        </p:nvGrpSpPr>
        <p:grpSpPr>
          <a:xfrm>
            <a:off x="5894388" y="3824288"/>
            <a:ext cx="2813050" cy="1974850"/>
            <a:chOff x="1624355" y="1998187"/>
            <a:chExt cx="2813050" cy="1974850"/>
          </a:xfrm>
        </p:grpSpPr>
        <p:graphicFrame>
          <p:nvGraphicFramePr>
            <p:cNvPr id="16" name="Object 15">
              <a:extLst>
                <a:ext uri="{FF2B5EF4-FFF2-40B4-BE49-F238E27FC236}">
                  <a16:creationId xmlns:a16="http://schemas.microsoft.com/office/drawing/2014/main" id="{03850852-0B9A-E52D-EA56-4DD3A532E853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1624355" y="1998187"/>
            <a:ext cx="2813050" cy="19748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6" imgW="3848050" imgH="2700075" progId="Prism9.Document">
                    <p:embed/>
                  </p:oleObj>
                </mc:Choice>
                <mc:Fallback>
                  <p:oleObj name="Prism 9" r:id="rId16" imgW="3848050" imgH="2700075" progId="Prism9.Document">
                    <p:embed/>
                    <p:pic>
                      <p:nvPicPr>
                        <p:cNvPr id="16" name="Object 15">
                          <a:extLst>
                            <a:ext uri="{FF2B5EF4-FFF2-40B4-BE49-F238E27FC236}">
                              <a16:creationId xmlns:a16="http://schemas.microsoft.com/office/drawing/2014/main" id="{03850852-0B9A-E52D-EA56-4DD3A532E85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1624355" y="1998187"/>
                          <a:ext cx="2813050" cy="19748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8" name="Text Box 2">
              <a:extLst>
                <a:ext uri="{FF2B5EF4-FFF2-40B4-BE49-F238E27FC236}">
                  <a16:creationId xmlns:a16="http://schemas.microsoft.com/office/drawing/2014/main" id="{B2884671-BF85-1CC2-CE7E-C0B77B0961C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22511" y="3073592"/>
              <a:ext cx="678340" cy="2018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700" b="1" i="1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p</a:t>
              </a:r>
              <a:r>
                <a:rPr lang="en-US" sz="700" b="1" i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= &lt;</a:t>
              </a:r>
              <a:r>
                <a:rPr lang="en-US" sz="700" b="1" i="1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0.0001</a:t>
              </a:r>
              <a:endParaRPr lang="en-US" sz="1100" b="1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9" name="Text Box 2">
            <a:extLst>
              <a:ext uri="{FF2B5EF4-FFF2-40B4-BE49-F238E27FC236}">
                <a16:creationId xmlns:a16="http://schemas.microsoft.com/office/drawing/2014/main" id="{F2CACCD0-228E-2BD6-49B8-06F65202384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931375" y="1966389"/>
            <a:ext cx="678340" cy="201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700" b="1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700" b="1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</a:t>
            </a:r>
            <a:r>
              <a:rPr lang="en-US" sz="700" b="1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0.5</a:t>
            </a:r>
            <a:endParaRPr lang="en-US" sz="1100" b="1" i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0" name="Text Box 2">
            <a:extLst>
              <a:ext uri="{FF2B5EF4-FFF2-40B4-BE49-F238E27FC236}">
                <a16:creationId xmlns:a16="http://schemas.microsoft.com/office/drawing/2014/main" id="{E34E6511-4D1B-A435-D49C-0D248B7DA4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41817" y="2104925"/>
            <a:ext cx="678340" cy="201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700" b="1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700" b="1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</a:t>
            </a:r>
            <a:r>
              <a:rPr lang="en-US" sz="700" b="1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0.16</a:t>
            </a:r>
            <a:endParaRPr lang="en-US" sz="1100" b="1" i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1" name="Text Box 2">
            <a:extLst>
              <a:ext uri="{FF2B5EF4-FFF2-40B4-BE49-F238E27FC236}">
                <a16:creationId xmlns:a16="http://schemas.microsoft.com/office/drawing/2014/main" id="{1E2B8EC5-FA57-3BAA-2311-421FC8B2F00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80951" y="4851618"/>
            <a:ext cx="678340" cy="201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700" b="1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700" b="1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&lt;0.0001</a:t>
            </a:r>
            <a:endParaRPr lang="en-US" sz="1100" b="1" i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2" name="Text Box 2">
            <a:extLst>
              <a:ext uri="{FF2B5EF4-FFF2-40B4-BE49-F238E27FC236}">
                <a16:creationId xmlns:a16="http://schemas.microsoft.com/office/drawing/2014/main" id="{53D213F5-D0F7-CB7E-FB23-1E36E4A02C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17566" y="4768390"/>
            <a:ext cx="678340" cy="201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700" b="1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700" b="1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0.02</a:t>
            </a:r>
            <a:endParaRPr lang="en-US" sz="1100" b="1" i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33" name="Group 32">
            <a:extLst>
              <a:ext uri="{FF2B5EF4-FFF2-40B4-BE49-F238E27FC236}">
                <a16:creationId xmlns:a16="http://schemas.microsoft.com/office/drawing/2014/main" id="{DB4220AD-D5F8-63F2-D9E1-DF0F540658CF}"/>
              </a:ext>
            </a:extLst>
          </p:cNvPr>
          <p:cNvGrpSpPr/>
          <p:nvPr/>
        </p:nvGrpSpPr>
        <p:grpSpPr>
          <a:xfrm>
            <a:off x="731492" y="696260"/>
            <a:ext cx="4909351" cy="372205"/>
            <a:chOff x="1007362" y="404920"/>
            <a:chExt cx="4909351" cy="372205"/>
          </a:xfrm>
        </p:grpSpPr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A6E72979-FD59-A0B4-B738-E2719D904641}"/>
                </a:ext>
              </a:extLst>
            </p:cNvPr>
            <p:cNvSpPr txBox="1"/>
            <p:nvPr/>
          </p:nvSpPr>
          <p:spPr>
            <a:xfrm>
              <a:off x="3181479" y="404920"/>
              <a:ext cx="5611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Sex</a:t>
              </a:r>
            </a:p>
          </p:txBody>
        </p:sp>
        <p:cxnSp>
          <p:nvCxnSpPr>
            <p:cNvPr id="35" name="Straight Arrow Connector 34">
              <a:extLst>
                <a:ext uri="{FF2B5EF4-FFF2-40B4-BE49-F238E27FC236}">
                  <a16:creationId xmlns:a16="http://schemas.microsoft.com/office/drawing/2014/main" id="{6E76E51F-575A-D8DD-33F7-BD4C278BC9CD}"/>
                </a:ext>
              </a:extLst>
            </p:cNvPr>
            <p:cNvCxnSpPr/>
            <p:nvPr/>
          </p:nvCxnSpPr>
          <p:spPr>
            <a:xfrm>
              <a:off x="1007362" y="777125"/>
              <a:ext cx="4909351" cy="0"/>
            </a:xfrm>
            <a:prstGeom prst="straightConnector1">
              <a:avLst/>
            </a:prstGeom>
            <a:ln w="38100">
              <a:headEnd type="triangl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6" name="Group 35">
            <a:extLst>
              <a:ext uri="{FF2B5EF4-FFF2-40B4-BE49-F238E27FC236}">
                <a16:creationId xmlns:a16="http://schemas.microsoft.com/office/drawing/2014/main" id="{29EA0CD7-FAF8-5A86-E146-AC939E4F1FBD}"/>
              </a:ext>
            </a:extLst>
          </p:cNvPr>
          <p:cNvGrpSpPr/>
          <p:nvPr/>
        </p:nvGrpSpPr>
        <p:grpSpPr>
          <a:xfrm>
            <a:off x="6424703" y="645920"/>
            <a:ext cx="4909351" cy="406977"/>
            <a:chOff x="1007362" y="370148"/>
            <a:chExt cx="4909351" cy="406977"/>
          </a:xfrm>
        </p:grpSpPr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D94484D3-6841-C680-D47F-BF8DE6C71E65}"/>
                </a:ext>
              </a:extLst>
            </p:cNvPr>
            <p:cNvSpPr txBox="1"/>
            <p:nvPr/>
          </p:nvSpPr>
          <p:spPr>
            <a:xfrm>
              <a:off x="2714373" y="370148"/>
              <a:ext cx="15971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Site/Location</a:t>
              </a:r>
            </a:p>
          </p:txBody>
        </p:sp>
        <p:cxnSp>
          <p:nvCxnSpPr>
            <p:cNvPr id="38" name="Straight Arrow Connector 37">
              <a:extLst>
                <a:ext uri="{FF2B5EF4-FFF2-40B4-BE49-F238E27FC236}">
                  <a16:creationId xmlns:a16="http://schemas.microsoft.com/office/drawing/2014/main" id="{80432C5C-ACE1-6E54-166E-940714BDBA2A}"/>
                </a:ext>
              </a:extLst>
            </p:cNvPr>
            <p:cNvCxnSpPr/>
            <p:nvPr/>
          </p:nvCxnSpPr>
          <p:spPr>
            <a:xfrm>
              <a:off x="1007362" y="777125"/>
              <a:ext cx="4909351" cy="0"/>
            </a:xfrm>
            <a:prstGeom prst="straightConnector1">
              <a:avLst/>
            </a:prstGeom>
            <a:ln w="38100">
              <a:headEnd type="triangl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9" name="Group 38">
            <a:extLst>
              <a:ext uri="{FF2B5EF4-FFF2-40B4-BE49-F238E27FC236}">
                <a16:creationId xmlns:a16="http://schemas.microsoft.com/office/drawing/2014/main" id="{053EF15D-C13A-41D3-E021-89D89CDAB3E5}"/>
              </a:ext>
            </a:extLst>
          </p:cNvPr>
          <p:cNvGrpSpPr/>
          <p:nvPr/>
        </p:nvGrpSpPr>
        <p:grpSpPr>
          <a:xfrm>
            <a:off x="6303432" y="3309977"/>
            <a:ext cx="4909351" cy="372205"/>
            <a:chOff x="1007362" y="404920"/>
            <a:chExt cx="4909351" cy="372205"/>
          </a:xfrm>
        </p:grpSpPr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2A5FC2EE-8C41-9810-53CE-2FF38C552258}"/>
                </a:ext>
              </a:extLst>
            </p:cNvPr>
            <p:cNvSpPr txBox="1"/>
            <p:nvPr/>
          </p:nvSpPr>
          <p:spPr>
            <a:xfrm>
              <a:off x="3181479" y="404920"/>
              <a:ext cx="96667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N stage</a:t>
              </a:r>
            </a:p>
          </p:txBody>
        </p:sp>
        <p:cxnSp>
          <p:nvCxnSpPr>
            <p:cNvPr id="41" name="Straight Arrow Connector 40">
              <a:extLst>
                <a:ext uri="{FF2B5EF4-FFF2-40B4-BE49-F238E27FC236}">
                  <a16:creationId xmlns:a16="http://schemas.microsoft.com/office/drawing/2014/main" id="{F9A1FFE0-2C69-5A7A-A1DB-68CFD18094E9}"/>
                </a:ext>
              </a:extLst>
            </p:cNvPr>
            <p:cNvCxnSpPr/>
            <p:nvPr/>
          </p:nvCxnSpPr>
          <p:spPr>
            <a:xfrm>
              <a:off x="1007362" y="777125"/>
              <a:ext cx="4909351" cy="0"/>
            </a:xfrm>
            <a:prstGeom prst="straightConnector1">
              <a:avLst/>
            </a:prstGeom>
            <a:ln w="38100">
              <a:headEnd type="triangl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2" name="Group 41">
            <a:extLst>
              <a:ext uri="{FF2B5EF4-FFF2-40B4-BE49-F238E27FC236}">
                <a16:creationId xmlns:a16="http://schemas.microsoft.com/office/drawing/2014/main" id="{58BB91D9-E057-76D7-14D0-C690AE4A04C2}"/>
              </a:ext>
            </a:extLst>
          </p:cNvPr>
          <p:cNvGrpSpPr/>
          <p:nvPr/>
        </p:nvGrpSpPr>
        <p:grpSpPr>
          <a:xfrm>
            <a:off x="585156" y="3328838"/>
            <a:ext cx="4909351" cy="372205"/>
            <a:chOff x="1007362" y="404920"/>
            <a:chExt cx="4909351" cy="372205"/>
          </a:xfrm>
        </p:grpSpPr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0AFF02FF-1EEC-3BE0-1E5B-2F98D7A9A8E0}"/>
                </a:ext>
              </a:extLst>
            </p:cNvPr>
            <p:cNvSpPr txBox="1"/>
            <p:nvPr/>
          </p:nvSpPr>
          <p:spPr>
            <a:xfrm>
              <a:off x="3181479" y="404920"/>
              <a:ext cx="9169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T stage</a:t>
              </a:r>
            </a:p>
          </p:txBody>
        </p:sp>
        <p:cxnSp>
          <p:nvCxnSpPr>
            <p:cNvPr id="44" name="Straight Arrow Connector 43">
              <a:extLst>
                <a:ext uri="{FF2B5EF4-FFF2-40B4-BE49-F238E27FC236}">
                  <a16:creationId xmlns:a16="http://schemas.microsoft.com/office/drawing/2014/main" id="{37EBD910-5D9F-BB0C-CF1E-567938C74734}"/>
                </a:ext>
              </a:extLst>
            </p:cNvPr>
            <p:cNvCxnSpPr/>
            <p:nvPr/>
          </p:nvCxnSpPr>
          <p:spPr>
            <a:xfrm>
              <a:off x="1007362" y="777125"/>
              <a:ext cx="4909351" cy="0"/>
            </a:xfrm>
            <a:prstGeom prst="straightConnector1">
              <a:avLst/>
            </a:prstGeom>
            <a:ln w="38100">
              <a:headEnd type="triangl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5" name="TextBox 44">
            <a:extLst>
              <a:ext uri="{FF2B5EF4-FFF2-40B4-BE49-F238E27FC236}">
                <a16:creationId xmlns:a16="http://schemas.microsoft.com/office/drawing/2014/main" id="{C3622206-B4EB-ABC4-D5CE-55B3B0585DB5}"/>
              </a:ext>
            </a:extLst>
          </p:cNvPr>
          <p:cNvSpPr txBox="1"/>
          <p:nvPr/>
        </p:nvSpPr>
        <p:spPr>
          <a:xfrm>
            <a:off x="425998" y="1113963"/>
            <a:ext cx="2952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081CAEA-B598-69FD-A8FD-56715485C190}"/>
              </a:ext>
            </a:extLst>
          </p:cNvPr>
          <p:cNvSpPr txBox="1"/>
          <p:nvPr/>
        </p:nvSpPr>
        <p:spPr>
          <a:xfrm>
            <a:off x="3362435" y="1169097"/>
            <a:ext cx="2952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CF53F60C-4471-5C5E-FE74-A5425E916AE4}"/>
              </a:ext>
            </a:extLst>
          </p:cNvPr>
          <p:cNvSpPr txBox="1"/>
          <p:nvPr/>
        </p:nvSpPr>
        <p:spPr>
          <a:xfrm>
            <a:off x="6058495" y="1169096"/>
            <a:ext cx="3113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1ED2036-5498-F051-B558-355586960550}"/>
              </a:ext>
            </a:extLst>
          </p:cNvPr>
          <p:cNvSpPr txBox="1"/>
          <p:nvPr/>
        </p:nvSpPr>
        <p:spPr>
          <a:xfrm>
            <a:off x="9115375" y="1176292"/>
            <a:ext cx="3113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D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ED944F4-8787-8DC3-5098-4411145180EF}"/>
              </a:ext>
            </a:extLst>
          </p:cNvPr>
          <p:cNvSpPr txBox="1"/>
          <p:nvPr/>
        </p:nvSpPr>
        <p:spPr>
          <a:xfrm>
            <a:off x="3362435" y="3811791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663375B6-2662-CDE3-8762-7E2512751E6B}"/>
              </a:ext>
            </a:extLst>
          </p:cNvPr>
          <p:cNvSpPr txBox="1"/>
          <p:nvPr/>
        </p:nvSpPr>
        <p:spPr>
          <a:xfrm>
            <a:off x="9104647" y="3742484"/>
            <a:ext cx="3161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H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EFA4E54F-149D-92B0-A510-DD50937CADB1}"/>
              </a:ext>
            </a:extLst>
          </p:cNvPr>
          <p:cNvSpPr txBox="1"/>
          <p:nvPr/>
        </p:nvSpPr>
        <p:spPr>
          <a:xfrm>
            <a:off x="6081769" y="3770911"/>
            <a:ext cx="312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G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ED5421D9-717B-A139-27FC-95117116829F}"/>
              </a:ext>
            </a:extLst>
          </p:cNvPr>
          <p:cNvSpPr txBox="1"/>
          <p:nvPr/>
        </p:nvSpPr>
        <p:spPr>
          <a:xfrm>
            <a:off x="436218" y="3832473"/>
            <a:ext cx="2872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E</a:t>
            </a:r>
          </a:p>
        </p:txBody>
      </p:sp>
      <p:sp>
        <p:nvSpPr>
          <p:cNvPr id="2" name="TextBox 3">
            <a:extLst>
              <a:ext uri="{FF2B5EF4-FFF2-40B4-BE49-F238E27FC236}">
                <a16:creationId xmlns:a16="http://schemas.microsoft.com/office/drawing/2014/main" id="{3D8FFADF-26A7-439D-9B5F-8B22B8BAF88B}"/>
              </a:ext>
            </a:extLst>
          </p:cNvPr>
          <p:cNvSpPr txBox="1"/>
          <p:nvPr/>
        </p:nvSpPr>
        <p:spPr>
          <a:xfrm>
            <a:off x="233363" y="5957996"/>
            <a:ext cx="11376352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algn="just">
              <a:spcBef>
                <a:spcPts val="0"/>
              </a:spcBef>
            </a:pPr>
            <a:r>
              <a:rPr lang="en-US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l Figure 4. Prognostic impact of pathological factors in OSCCs. 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hown are Kaplan-Meier estimates of overall survival (A,C,E,G) and progression free survival (B,D,F,H) of OSCC patients stratified by s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x </a:t>
            </a:r>
            <a:r>
              <a:rPr lang="en-US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A,B), disease site/location (C,D), T stage (E,F), and N stage (G,H).  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35477155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9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9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urnett, Andrean L</dc:creator>
  <cp:lastModifiedBy>Burnett, Andrean L</cp:lastModifiedBy>
  <cp:revision>2</cp:revision>
  <dcterms:created xsi:type="dcterms:W3CDTF">2024-05-01T14:54:02Z</dcterms:created>
  <dcterms:modified xsi:type="dcterms:W3CDTF">2024-05-01T17:40:53Z</dcterms:modified>
</cp:coreProperties>
</file>